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774CE4-6818-4DE3-A4C4-8F89EB0BE7E2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The red dots are the locations of the capita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Link: http://www.asaida.org.br/mapa-brasil.htm, accessed September 08, 2008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8CBDE0-A54D-4EE7-BECC-37A6022493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E18417-2C33-4858-944A-1282EE5F1D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BBADB0-21DB-474C-A2C7-7696F27A259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120629-6817-42EB-87A1-771DF5FBC5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E1D6C7-9174-4D93-81F0-1409CF3E33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34F129-455A-4D0A-9C74-A29A8C0042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83F616-E3AA-4B1D-A6BC-F3E29A48ED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E0964-7626-4B51-BE87-E6357D3D7A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7B3500-B17B-44D8-B404-732E6DEC75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7BA301-E3D4-4275-9509-9DCD80EB6A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8CA186-4D1B-45E6-BEE1-A0ED7352E4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FBDF6-E1E4-4A5D-98C6-445291BF52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C84F006-63B6-49F3-96F9-28D98940A79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3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The five regions of Brazil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1187280" y="1700280"/>
            <a:ext cx="5289840" cy="465444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5292720" y="5157720"/>
            <a:ext cx="2808360" cy="70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orth Reg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272200" y="5248440"/>
            <a:ext cx="18396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6156360" y="5084640"/>
            <a:ext cx="187164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292720" y="5373720"/>
            <a:ext cx="2305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ortheast Reg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5292720" y="5805360"/>
            <a:ext cx="2305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outheast Reg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292720" y="6021360"/>
            <a:ext cx="2305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outh Reg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292720" y="5589720"/>
            <a:ext cx="2305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enter-West Reg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0" y="0"/>
            <a:ext cx="9144000" cy="105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3200" spc="-1" strike="noStrike">
                <a:solidFill>
                  <a:srgbClr val="000000"/>
                </a:solidFill>
                <a:latin typeface="Arial"/>
              </a:rPr>
              <a:t>Map of Brazil (only the studied cities are referenced)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 type="subTitle"/>
          </p:nvPr>
        </p:nvSpPr>
        <p:spPr>
          <a:xfrm>
            <a:off x="4284720" y="1052640"/>
            <a:ext cx="4859280" cy="58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66ff"/>
                </a:solidFill>
                <a:latin typeface="Arial"/>
              </a:rPr>
              <a:t>Brazilian states and their capital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3 - Amazonas: Manau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4 - Pará: Belé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7 - Ceará: Fortalez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8 - Rio Grande do Norte: Nat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9 - Paraíba: João Pesso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10 - Pernambuco: Recif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12 - Sergipe: Aracaju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19 - Federal District: Brasíli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20 - Minas Gerais: Belo Horizon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21 - Espírito Santo: Vitóri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22 - Rio de Janeiro: Rio de Janeiro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23 - Mato Grosso do Sul: Campo Gran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24 - São Paulo: São Paul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25 - Paraná: Curitib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26 - Santa Catarina: Florianópol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27 - Rio Grande do Sul: Porto Aleg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 algn="ctr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" descr=""/>
          <p:cNvPicPr/>
          <p:nvPr/>
        </p:nvPicPr>
        <p:blipFill>
          <a:blip r:embed="rId1"/>
          <a:srcRect l="0" t="0" r="0" b="-52493"/>
          <a:stretch/>
        </p:blipFill>
        <p:spPr>
          <a:xfrm>
            <a:off x="0" y="1268280"/>
            <a:ext cx="4465800" cy="8542440"/>
          </a:xfrm>
          <a:prstGeom prst="rect">
            <a:avLst/>
          </a:prstGeom>
          <a:ln w="0">
            <a:noFill/>
          </a:ln>
        </p:spPr>
      </p:pic>
      <p:sp>
        <p:nvSpPr>
          <p:cNvPr id="60" name=""/>
          <p:cNvSpPr/>
          <p:nvPr/>
        </p:nvSpPr>
        <p:spPr>
          <a:xfrm>
            <a:off x="0" y="5516640"/>
            <a:ext cx="450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ff0000"/>
                </a:solidFill>
                <a:latin typeface="Arial"/>
              </a:rPr>
              <a:t>The red point is the location of the capit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08T20:18:30Z</dcterms:created>
  <dc:creator>*</dc:creator>
  <dc:description/>
  <dc:language>en-US</dc:language>
  <cp:lastModifiedBy>Dr. Paulo</cp:lastModifiedBy>
  <dcterms:modified xsi:type="dcterms:W3CDTF">2009-06-20T18:20:52Z</dcterms:modified>
  <cp:revision>16</cp:revision>
  <dc:subject/>
  <dc:title>Map of Brazil (only the cities studied are referenced)</dc:title>
</cp:coreProperties>
</file>